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1392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Pita2!$C$2</c:f>
              <c:strCache>
                <c:ptCount val="1"/>
                <c:pt idx="0">
                  <c:v>IRBL28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Pita2!$E$11:$E$1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6.1471586502621182E-2</c:v>
                  </c:pt>
                  <c:pt idx="2">
                    <c:v>9.1283862512845371E-3</c:v>
                  </c:pt>
                  <c:pt idx="3">
                    <c:v>7.3377681880945608E-2</c:v>
                  </c:pt>
                  <c:pt idx="4">
                    <c:v>0.20122135275846592</c:v>
                  </c:pt>
                  <c:pt idx="5">
                    <c:v>0.17364422761969428</c:v>
                  </c:pt>
                </c:numCache>
              </c:numRef>
            </c:plus>
            <c:minus>
              <c:numRef>
                <c:f>Pita2!$E$11:$E$16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6.1471586502621182E-2</c:v>
                  </c:pt>
                  <c:pt idx="2">
                    <c:v>9.1283862512845371E-3</c:v>
                  </c:pt>
                  <c:pt idx="3">
                    <c:v>7.3377681880945608E-2</c:v>
                  </c:pt>
                  <c:pt idx="4">
                    <c:v>0.20122135275846592</c:v>
                  </c:pt>
                  <c:pt idx="5">
                    <c:v>0.17364422761969428</c:v>
                  </c:pt>
                </c:numCache>
              </c:numRef>
            </c:minus>
          </c:errBars>
          <c:cat>
            <c:strRef>
              <c:f>Pita2!$B$3:$B$7</c:f>
              <c:strCache>
                <c:ptCount val="5"/>
                <c:pt idx="0">
                  <c:v>0h</c:v>
                </c:pt>
                <c:pt idx="1">
                  <c:v>12h</c:v>
                </c:pt>
                <c:pt idx="2">
                  <c:v>24h</c:v>
                </c:pt>
                <c:pt idx="3">
                  <c:v>36h</c:v>
                </c:pt>
                <c:pt idx="4">
                  <c:v>72h</c:v>
                </c:pt>
              </c:strCache>
            </c:strRef>
          </c:cat>
          <c:val>
            <c:numRef>
              <c:f>Pita2!$C$3:$C$7</c:f>
              <c:numCache>
                <c:formatCode>General</c:formatCode>
                <c:ptCount val="5"/>
                <c:pt idx="0">
                  <c:v>1</c:v>
                </c:pt>
                <c:pt idx="1">
                  <c:v>0.87372398285885833</c:v>
                </c:pt>
                <c:pt idx="2">
                  <c:v>0.60786773856074949</c:v>
                </c:pt>
                <c:pt idx="3">
                  <c:v>1.3245987123057872</c:v>
                </c:pt>
                <c:pt idx="4">
                  <c:v>1.50233004171620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3F1-4C8D-9DC6-449C647E66CA}"/>
            </c:ext>
          </c:extLst>
        </c:ser>
        <c:ser>
          <c:idx val="1"/>
          <c:order val="1"/>
          <c:tx>
            <c:strRef>
              <c:f>Pita2!$D$2</c:f>
              <c:strCache>
                <c:ptCount val="1"/>
                <c:pt idx="0">
                  <c:v>CN16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Pita2!$E$22:$E$2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3052527554018829E-2</c:v>
                  </c:pt>
                  <c:pt idx="2">
                    <c:v>6.7746097895253479E-3</c:v>
                  </c:pt>
                  <c:pt idx="3">
                    <c:v>0.29652261635742561</c:v>
                  </c:pt>
                  <c:pt idx="4">
                    <c:v>7.4495353306065437E-2</c:v>
                  </c:pt>
                  <c:pt idx="5">
                    <c:v>0.23895932938769321</c:v>
                  </c:pt>
                </c:numCache>
              </c:numRef>
            </c:plus>
            <c:minus>
              <c:numRef>
                <c:f>Pita2!$E$22:$E$27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3.3052527554018829E-2</c:v>
                  </c:pt>
                  <c:pt idx="2">
                    <c:v>6.7746097895253479E-3</c:v>
                  </c:pt>
                  <c:pt idx="3">
                    <c:v>0.29652261635742561</c:v>
                  </c:pt>
                  <c:pt idx="4">
                    <c:v>7.4495353306065437E-2</c:v>
                  </c:pt>
                  <c:pt idx="5">
                    <c:v>0.23895932938769321</c:v>
                  </c:pt>
                </c:numCache>
              </c:numRef>
            </c:minus>
          </c:errBars>
          <c:cat>
            <c:strRef>
              <c:f>Pita2!$B$3:$B$7</c:f>
              <c:strCache>
                <c:ptCount val="5"/>
                <c:pt idx="0">
                  <c:v>0h</c:v>
                </c:pt>
                <c:pt idx="1">
                  <c:v>12h</c:v>
                </c:pt>
                <c:pt idx="2">
                  <c:v>24h</c:v>
                </c:pt>
                <c:pt idx="3">
                  <c:v>36h</c:v>
                </c:pt>
                <c:pt idx="4">
                  <c:v>72h</c:v>
                </c:pt>
              </c:strCache>
            </c:strRef>
          </c:cat>
          <c:val>
            <c:numRef>
              <c:f>Pita2!$D$3:$D$7</c:f>
              <c:numCache>
                <c:formatCode>General</c:formatCode>
                <c:ptCount val="5"/>
                <c:pt idx="0">
                  <c:v>1</c:v>
                </c:pt>
                <c:pt idx="1">
                  <c:v>0.66593082453916042</c:v>
                </c:pt>
                <c:pt idx="2">
                  <c:v>0.4511969772053287</c:v>
                </c:pt>
                <c:pt idx="3">
                  <c:v>1.0260344740058593</c:v>
                </c:pt>
                <c:pt idx="4">
                  <c:v>1.04002920697731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3F1-4C8D-9DC6-449C647E66CA}"/>
            </c:ext>
          </c:extLst>
        </c:ser>
        <c:ser>
          <c:idx val="2"/>
          <c:order val="2"/>
          <c:tx>
            <c:strRef>
              <c:f>Pita2!$E$2</c:f>
              <c:strCache>
                <c:ptCount val="1"/>
                <c:pt idx="0">
                  <c:v>IR64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Pita2!$E$30:$E$3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5400599640290618E-6</c:v>
                  </c:pt>
                  <c:pt idx="2">
                    <c:v>3.3623218474776229E-2</c:v>
                  </c:pt>
                  <c:pt idx="3">
                    <c:v>0.20046187057141124</c:v>
                  </c:pt>
                  <c:pt idx="4">
                    <c:v>8.8973742844875914E-2</c:v>
                  </c:pt>
                  <c:pt idx="5">
                    <c:v>0.14060209985949046</c:v>
                  </c:pt>
                </c:numCache>
              </c:numRef>
            </c:plus>
            <c:minus>
              <c:numRef>
                <c:f>Pita2!$E$30:$E$35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2.5400599640290618E-6</c:v>
                  </c:pt>
                  <c:pt idx="2">
                    <c:v>3.3623218474776229E-2</c:v>
                  </c:pt>
                  <c:pt idx="3">
                    <c:v>0.20046187057141124</c:v>
                  </c:pt>
                  <c:pt idx="4">
                    <c:v>8.8973742844875914E-2</c:v>
                  </c:pt>
                  <c:pt idx="5">
                    <c:v>0.14060209985949046</c:v>
                  </c:pt>
                </c:numCache>
              </c:numRef>
            </c:minus>
          </c:errBars>
          <c:cat>
            <c:strRef>
              <c:f>Pita2!$B$3:$B$7</c:f>
              <c:strCache>
                <c:ptCount val="5"/>
                <c:pt idx="0">
                  <c:v>0h</c:v>
                </c:pt>
                <c:pt idx="1">
                  <c:v>12h</c:v>
                </c:pt>
                <c:pt idx="2">
                  <c:v>24h</c:v>
                </c:pt>
                <c:pt idx="3">
                  <c:v>36h</c:v>
                </c:pt>
                <c:pt idx="4">
                  <c:v>72h</c:v>
                </c:pt>
              </c:strCache>
            </c:strRef>
          </c:cat>
          <c:val>
            <c:numRef>
              <c:f>Pita2!$E$3:$E$7</c:f>
              <c:numCache>
                <c:formatCode>General</c:formatCode>
                <c:ptCount val="5"/>
                <c:pt idx="0">
                  <c:v>1</c:v>
                </c:pt>
                <c:pt idx="1">
                  <c:v>1.0993595733252337</c:v>
                </c:pt>
                <c:pt idx="2">
                  <c:v>0.54471820096686263</c:v>
                </c:pt>
                <c:pt idx="3">
                  <c:v>1.5048079129645024</c:v>
                </c:pt>
                <c:pt idx="4">
                  <c:v>1.52571156797040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3F1-4C8D-9DC6-449C647E66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4428928"/>
        <c:axId val="159085056"/>
      </c:barChart>
      <c:catAx>
        <c:axId val="1544289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59085056"/>
        <c:crosses val="autoZero"/>
        <c:auto val="1"/>
        <c:lblAlgn val="ctr"/>
        <c:lblOffset val="100"/>
        <c:noMultiLvlLbl val="0"/>
      </c:catAx>
      <c:valAx>
        <c:axId val="159085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54428928"/>
        <c:crosses val="autoZero"/>
        <c:crossBetween val="between"/>
      </c:valAx>
    </c:plotArea>
    <c:legend>
      <c:legendPos val="r"/>
      <c:layout/>
      <c:overlay val="0"/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2522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11529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250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2948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0621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8218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1326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73286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1327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1164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2630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30C39E-8DD5-4FF1-9514-FDAA6D4F34B1}" type="datetimeFigureOut">
              <a:rPr lang="zh-CN" altLang="en-US" smtClean="0"/>
              <a:t>2019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B461E2-C8B9-4C5B-BC82-674180BABD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95269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251520" y="3854439"/>
            <a:ext cx="8281482" cy="2893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Fig. S1 Expression pattern of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Pita2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haplotypes in different rice varieties. Profiles of gene expression of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Pita2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in IRBL28, CN16, and IR64 at different time points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[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0, 12,  24, 36, 72 hours (h)] after inoculation with 98-06  isolate are analyzed using </a:t>
            </a:r>
            <a:r>
              <a:rPr lang="en-US" altLang="zh-CN" sz="1400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-PCR. The relative -2</a:t>
            </a:r>
            <a:r>
              <a:rPr lang="en-US" altLang="zh-CN" sz="1400" baseline="30000" dirty="0" smtClean="0">
                <a:latin typeface="Times New Roman" pitchFamily="18" charset="0"/>
                <a:cs typeface="Times New Roman" pitchFamily="18" charset="0"/>
              </a:rPr>
              <a:t>△△CT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method is used for the significance analysis of gene expression at different time points after infection compared to the one at 0h. The rice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1 is used as an internal control. Data represent means with error bars showing ± </a:t>
            </a:r>
            <a:r>
              <a:rPr lang="en-US" altLang="zh-CN" sz="1400" dirty="0" err="1" smtClean="0">
                <a:latin typeface="Times New Roman" pitchFamily="18" charset="0"/>
                <a:cs typeface="Times New Roman" pitchFamily="18" charset="0"/>
              </a:rPr>
              <a:t>s.d.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(n=2).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The procedure for the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-PCR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analysis is as follows: RNAs of plant leaf tissues at different time points were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extracted using “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Eastep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Super Total RNA Extraction Kit” (http://www.promega.com.cn/, Catalog number: LS1040).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GoScript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™ Reverse Transcription Kit (http://www.promega.com.cn/, Catalog number: A5000) was used for RNA reverse transcription. 1</a:t>
            </a:r>
            <a:r>
              <a:rPr lang="el-GR" altLang="zh-CN" sz="14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g of total RNA was used for RNA reverse transcription. SYBR Green Pro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Taq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HS qPCR kit (http://www.agbio.com.cn) was used for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-PCR using the cycle: 5</a:t>
            </a:r>
            <a:r>
              <a:rPr lang="el-GR" altLang="zh-CN" sz="14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L 2 x SYBR Green mix, 1</a:t>
            </a:r>
            <a:r>
              <a:rPr lang="el-GR" altLang="zh-CN" sz="14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L cDNA (20ng/</a:t>
            </a:r>
            <a:r>
              <a:rPr lang="el-GR" altLang="zh-CN" sz="14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L), 0.5</a:t>
            </a:r>
            <a:r>
              <a:rPr lang="el-GR" altLang="zh-CN" sz="14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L forward primer(10</a:t>
            </a:r>
            <a:r>
              <a:rPr lang="el-GR" altLang="zh-CN" sz="14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m/L), 1</a:t>
            </a:r>
            <a:r>
              <a:rPr lang="el-GR" altLang="zh-CN" sz="14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L reverse primer(10</a:t>
            </a:r>
            <a:r>
              <a:rPr lang="el-GR" altLang="zh-CN" sz="14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m/L) and 3</a:t>
            </a:r>
            <a:r>
              <a:rPr lang="el-GR" altLang="zh-CN" sz="1400" dirty="0">
                <a:latin typeface="Times New Roman" pitchFamily="18" charset="0"/>
                <a:cs typeface="Times New Roman" pitchFamily="18" charset="0"/>
              </a:rPr>
              <a:t>μ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L H2O. Pita2 F/R was used to amplify Pita2 and Actin F/R was used to amplify Actin 1 as internal control (Additional </a:t>
            </a:r>
            <a:r>
              <a:rPr lang="en-US" altLang="zh-CN" sz="1400">
                <a:latin typeface="Times New Roman" pitchFamily="18" charset="0"/>
                <a:cs typeface="Times New Roman" pitchFamily="18" charset="0"/>
              </a:rPr>
              <a:t>file </a:t>
            </a:r>
            <a:r>
              <a:rPr lang="en-US" altLang="zh-CN" sz="1400" smtClean="0">
                <a:latin typeface="Times New Roman" pitchFamily="18" charset="0"/>
                <a:cs typeface="Times New Roman" pitchFamily="18" charset="0"/>
              </a:rPr>
              <a:t>8: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Table S6). Eppendorf AG 22331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hamburgand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(https://www.eppendorf.com, Lot number: Z241676Q) was used to run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-PCR. </a:t>
            </a:r>
            <a:endParaRPr lang="zh-CN" altLang="en-US" sz="20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2267744" y="-1683568"/>
            <a:ext cx="5611670" cy="5392215"/>
            <a:chOff x="328482" y="-1531167"/>
            <a:chExt cx="5611670" cy="5392215"/>
          </a:xfrm>
        </p:grpSpPr>
        <p:graphicFrame>
          <p:nvGraphicFramePr>
            <p:cNvPr id="12" name="图表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203088785"/>
                </p:ext>
              </p:extLst>
            </p:nvPr>
          </p:nvGraphicFramePr>
          <p:xfrm>
            <a:off x="574350" y="476672"/>
            <a:ext cx="5365802" cy="338437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7" name="TextBox 16"/>
            <p:cNvSpPr txBox="1"/>
            <p:nvPr/>
          </p:nvSpPr>
          <p:spPr>
            <a:xfrm rot="-5400000">
              <a:off x="-1693258" y="490573"/>
              <a:ext cx="432048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 smtClean="0">
                  <a:latin typeface="Times New Roman" pitchFamily="18" charset="0"/>
                  <a:cs typeface="Times New Roman" pitchFamily="18" charset="0"/>
                </a:rPr>
                <a:t>Relative expression level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225482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</TotalTime>
  <Words>291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Zhou, Bo (FAORAP)</cp:lastModifiedBy>
  <cp:revision>28</cp:revision>
  <dcterms:created xsi:type="dcterms:W3CDTF">2019-12-02T06:05:31Z</dcterms:created>
  <dcterms:modified xsi:type="dcterms:W3CDTF">2019-12-04T03:36:26Z</dcterms:modified>
</cp:coreProperties>
</file>